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1350" y="3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34306F83-CB9E-4D6E-A91D-AD781A34677A}"/>
    <pc:docChg chg="modSld">
      <pc:chgData name="Enrique María Mateu de Antonio" userId="678ddb83-0020-4a06-85d2-928a222534ef" providerId="ADAL" clId="{34306F83-CB9E-4D6E-A91D-AD781A34677A}" dt="2025-04-07T13:46:22.232" v="9" actId="1076"/>
      <pc:docMkLst>
        <pc:docMk/>
      </pc:docMkLst>
      <pc:sldChg chg="addSp modSp mod">
        <pc:chgData name="Enrique María Mateu de Antonio" userId="678ddb83-0020-4a06-85d2-928a222534ef" providerId="ADAL" clId="{34306F83-CB9E-4D6E-A91D-AD781A34677A}" dt="2025-04-07T13:46:22.232" v="9" actId="1076"/>
        <pc:sldMkLst>
          <pc:docMk/>
          <pc:sldMk cId="3395346923" sldId="256"/>
        </pc:sldMkLst>
        <pc:spChg chg="add mod">
          <ac:chgData name="Enrique María Mateu de Antonio" userId="678ddb83-0020-4a06-85d2-928a222534ef" providerId="ADAL" clId="{34306F83-CB9E-4D6E-A91D-AD781A34677A}" dt="2025-04-07T13:46:16.101" v="8" actId="404"/>
          <ac:spMkLst>
            <pc:docMk/>
            <pc:sldMk cId="3395346923" sldId="256"/>
            <ac:spMk id="4" creationId="{47AF3AA9-82B1-2684-FB34-E98B62B31569}"/>
          </ac:spMkLst>
        </pc:spChg>
        <pc:graphicFrameChg chg="mod">
          <ac:chgData name="Enrique María Mateu de Antonio" userId="678ddb83-0020-4a06-85d2-928a222534ef" providerId="ADAL" clId="{34306F83-CB9E-4D6E-A91D-AD781A34677A}" dt="2025-04-07T13:46:22.232" v="9" actId="1076"/>
          <ac:graphicFrameMkLst>
            <pc:docMk/>
            <pc:sldMk cId="3395346923" sldId="256"/>
            <ac:graphicFrameMk id="3" creationId="{4057F127-397B-1B81-3756-B9C71925C932}"/>
          </ac:graphicFrameMkLst>
        </pc:graphicFrameChg>
      </pc:sldChg>
    </pc:docChg>
  </pc:docChgLst>
  <pc:docChgLst>
    <pc:chgData name="Enrique María Mateu de Antonio" userId="678ddb83-0020-4a06-85d2-928a222534ef" providerId="ADAL" clId="{3ACF65DB-FEF9-4811-BCF2-FBC25F50FC60}"/>
    <pc:docChg chg="modSld">
      <pc:chgData name="Enrique María Mateu de Antonio" userId="678ddb83-0020-4a06-85d2-928a222534ef" providerId="ADAL" clId="{3ACF65DB-FEF9-4811-BCF2-FBC25F50FC60}" dt="2025-04-22T12:47:38.357" v="3" actId="404"/>
      <pc:docMkLst>
        <pc:docMk/>
      </pc:docMkLst>
      <pc:sldChg chg="modSp mod">
        <pc:chgData name="Enrique María Mateu de Antonio" userId="678ddb83-0020-4a06-85d2-928a222534ef" providerId="ADAL" clId="{3ACF65DB-FEF9-4811-BCF2-FBC25F50FC60}" dt="2025-04-22T12:47:38.357" v="3" actId="404"/>
        <pc:sldMkLst>
          <pc:docMk/>
          <pc:sldMk cId="3395346923" sldId="256"/>
        </pc:sldMkLst>
        <pc:spChg chg="mod">
          <ac:chgData name="Enrique María Mateu de Antonio" userId="678ddb83-0020-4a06-85d2-928a222534ef" providerId="ADAL" clId="{3ACF65DB-FEF9-4811-BCF2-FBC25F50FC60}" dt="2025-04-22T12:47:38.357" v="3" actId="404"/>
          <ac:spMkLst>
            <pc:docMk/>
            <pc:sldMk cId="3395346923" sldId="256"/>
            <ac:spMk id="4" creationId="{47AF3AA9-82B1-2684-FB34-E98B62B3156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BA6A7FF7-0834-B8F1-687E-D6844DF588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374C0951-82B7-0486-C4B9-A0D86F2264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79E8351A-CD68-BE76-7EC0-6ED8E66C9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DDE1939A-A5F5-1425-AAAA-7CC06B438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A9B45533-459E-8A50-1D16-09E89048B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9413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1B0C6D9A-6A84-BCAB-4BF0-5932A855B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94A3B192-A223-4E2A-E65C-7ADB8BA9C8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3D4A665F-B47B-CF17-E2BD-168FAB645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6D221BB5-8F05-65D9-A5EF-E6DB8520B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AD96242B-1FB8-F181-F1E9-134D7BFC7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1616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6F7B08E7-93B5-6288-94A8-BF7E954F94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EDABFF73-55A5-CD2F-E73C-74F35F60E7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8C39E49E-3632-003B-3FCB-B391B4D9A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D0B91278-BBC7-73DA-B8CB-48741A545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DE01537F-A2ED-2BDD-3F9F-BAD17EB1A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93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683B4519-F57A-83C1-D520-5B18C19F2A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E3724447-D74D-AF4E-BCC3-9ACB79F599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28700CD4-9572-B834-E674-3A1A6583E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FD4EAE20-5AAA-DA00-B259-2D4AB0DCE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54E0ADE4-33D5-1671-0433-0A5322709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9792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656F5E46-05BD-5E3B-0211-7A8B55D20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E2D3616E-6324-08FC-75FD-F718418D73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114063B3-FEF5-DA4A-373C-3E3479124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0261C84F-68C9-FCC3-F19D-B257B1700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88F1DE5A-E42A-3948-B610-8D3AFD7DE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1441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7EF0C86A-E143-AF4F-DB9E-5659DCBB5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E0CA32EF-604D-E540-B47D-54CDD6811D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1B953143-1284-82D5-F746-554621BF09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BC9ACD35-4EE1-7E13-8FAE-8BD7A2D96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59212561-5DFF-7701-EA27-75839F501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ACBD04AA-52BA-2224-6C6A-C9C17F91E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7172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8DA0DBC-46B3-6E80-8279-58E6090F66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CA2D6CC9-6A96-7474-A1F8-D56B2CB27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6EEDF9FF-DD2E-43FD-FEC6-727F19C97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05856801-595B-F5DF-911B-ECA37C24B6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DBF53821-EB2D-31F3-2969-D71FEA6473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041057CB-3BF3-7154-31DD-34904A8DA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7051515B-5645-69FD-DEA3-DE3FD9493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43DF7799-DE26-32E7-58CE-FCEDA610B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6385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DE13AEE-91E9-82F3-DBCF-CD6E569653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467FFFA4-F446-44FE-E568-7F83E892F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737318BF-5CD0-666D-48BA-B7BF904E3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F6DCBCA0-A3FA-DE73-70BC-CF068A6DB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5180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59D1A41D-804D-4D67-E0FB-6F5CAA48E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905D23B1-C754-556C-ABED-71C2A10DCF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7E2C21DB-EBD9-020F-9A2C-198CBFA9A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9373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D13A574-F47D-4DBD-8E06-0A820A0AE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CAAFB6DB-13DF-7E82-8125-0B164FBDA2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1A4F5E3F-C1FA-BAE9-E0CE-B624BDC7D6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0C67E238-EE2F-9009-E232-7A4846E2B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A2EE3B0A-4CC1-5859-E460-1FF6C9F21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FE8F3435-4DA4-01D5-C96F-F4F7B15CA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407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74B55495-C242-AF10-AC82-5DE79FD117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139AA6E3-0BD6-7289-605B-BCA2260585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4A137B19-ADCC-9150-74C0-F530ECE06F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D25E32AE-FFCA-8E7D-9DD6-D77A0C809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43B64ACC-67FD-BF29-B9A0-812A4F460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5978C404-1121-397F-214B-ACF2506BD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2120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999D8960-278D-0E3B-6C51-5EE3BABEA6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3944B4CC-2298-074B-669B-F4C5CAD234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AD6CFAE6-5CFC-77DC-DB65-94608EAB53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AA1E7F-3103-4F31-A3C3-B648FA994BFE}" type="datetimeFigureOut">
              <a:rPr lang="es-ES" smtClean="0"/>
              <a:t>14/08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FB21939C-FD5C-2569-243D-799D8F1DF1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C9A871C6-0539-9C14-FB7E-127A28C524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169FA3-DA05-4319-8C1A-22216CD4F6D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1375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e 2">
            <a:extLst>
              <a:ext uri="{FF2B5EF4-FFF2-40B4-BE49-F238E27FC236}">
                <a16:creationId xmlns:a16="http://schemas.microsoft.com/office/drawing/2014/main" id="{4057F127-397B-1B81-3756-B9C71925C9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3476501"/>
              </p:ext>
            </p:extLst>
          </p:nvPr>
        </p:nvGraphicFramePr>
        <p:xfrm>
          <a:off x="2556668" y="1154113"/>
          <a:ext cx="707866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205429" imgH="7046774" progId="Prism10.Document">
                  <p:embed/>
                </p:oleObj>
              </mc:Choice>
              <mc:Fallback>
                <p:oleObj name="Prism 10" r:id="rId2" imgW="9205429" imgH="7046774" progId="Prism10.Document">
                  <p:embed/>
                  <p:pic>
                    <p:nvPicPr>
                      <p:cNvPr id="3" name="Objecte 2">
                        <a:extLst>
                          <a:ext uri="{FF2B5EF4-FFF2-40B4-BE49-F238E27FC236}">
                            <a16:creationId xmlns:a16="http://schemas.microsoft.com/office/drawing/2014/main" id="{4057F127-397B-1B81-3756-B9C71925C9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56668" y="1154113"/>
                        <a:ext cx="707866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QuadreDeText 3">
            <a:extLst>
              <a:ext uri="{FF2B5EF4-FFF2-40B4-BE49-F238E27FC236}">
                <a16:creationId xmlns:a16="http://schemas.microsoft.com/office/drawing/2014/main" id="{47AF3AA9-82B1-2684-FB34-E98B62B31569}"/>
              </a:ext>
            </a:extLst>
          </p:cNvPr>
          <p:cNvSpPr txBox="1"/>
          <p:nvPr/>
        </p:nvSpPr>
        <p:spPr>
          <a:xfrm>
            <a:off x="838200" y="285750"/>
            <a:ext cx="1091565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6.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ra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ad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determine after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ver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CID50/g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es-E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28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t-challeng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PC). NV/Ch = no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or =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cil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R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 = Innovac 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 = p&lt;0.05</a:t>
            </a:r>
          </a:p>
        </p:txBody>
      </p:sp>
    </p:spTree>
    <p:extLst>
      <p:ext uri="{BB962C8B-B14F-4D97-AF65-F5344CB8AC3E}">
        <p14:creationId xmlns:p14="http://schemas.microsoft.com/office/powerpoint/2010/main" val="33953469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B2A57E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icin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3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Tema de l'Office</vt:lpstr>
      <vt:lpstr>Prism 10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c mateu</cp:lastModifiedBy>
  <cp:revision>4</cp:revision>
  <dcterms:created xsi:type="dcterms:W3CDTF">2025-02-07T14:24:14Z</dcterms:created>
  <dcterms:modified xsi:type="dcterms:W3CDTF">2025-08-14T18:36:03Z</dcterms:modified>
</cp:coreProperties>
</file>